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3" r:id="rId6"/>
    <p:sldId id="262" r:id="rId7"/>
    <p:sldId id="264" r:id="rId8"/>
    <p:sldId id="266" r:id="rId9"/>
    <p:sldId id="265" r:id="rId10"/>
    <p:sldId id="26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F0F6"/>
    <a:srgbClr val="CDA809"/>
    <a:srgbClr val="F5BF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6126D85-726E-49BE-95B0-1A2DE300E17F}" v="77" dt="2025-10-21T17:43:57.2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799" autoAdjust="0"/>
    <p:restoredTop sz="94679"/>
  </p:normalViewPr>
  <p:slideViewPr>
    <p:cSldViewPr snapToGrid="0">
      <p:cViewPr varScale="1">
        <p:scale>
          <a:sx n="78" d="100"/>
          <a:sy n="78" d="100"/>
        </p:scale>
        <p:origin x="130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ian Robinson" userId="0641c4c5-2f89-46b7-a1c0-255ee54644ae" providerId="ADAL" clId="{ED66AB01-BF40-454D-9816-B00C85E3E4E3}"/>
    <pc:docChg chg="undo custSel modSld">
      <pc:chgData name="Brian Robinson" userId="0641c4c5-2f89-46b7-a1c0-255ee54644ae" providerId="ADAL" clId="{ED66AB01-BF40-454D-9816-B00C85E3E4E3}" dt="2025-10-21T17:48:21.332" v="556" actId="1076"/>
      <pc:docMkLst>
        <pc:docMk/>
      </pc:docMkLst>
      <pc:sldChg chg="addSp modSp mod">
        <pc:chgData name="Brian Robinson" userId="0641c4c5-2f89-46b7-a1c0-255ee54644ae" providerId="ADAL" clId="{ED66AB01-BF40-454D-9816-B00C85E3E4E3}" dt="2025-10-21T14:17:24.422" v="389" actId="14100"/>
        <pc:sldMkLst>
          <pc:docMk/>
          <pc:sldMk cId="349248455" sldId="257"/>
        </pc:sldMkLst>
        <pc:spChg chg="mod">
          <ac:chgData name="Brian Robinson" userId="0641c4c5-2f89-46b7-a1c0-255ee54644ae" providerId="ADAL" clId="{ED66AB01-BF40-454D-9816-B00C85E3E4E3}" dt="2025-10-21T14:14:06.771" v="356" actId="20577"/>
          <ac:spMkLst>
            <pc:docMk/>
            <pc:sldMk cId="349248455" sldId="257"/>
            <ac:spMk id="2" creationId="{4458A319-0C10-171B-BB90-693E0C455786}"/>
          </ac:spMkLst>
        </pc:spChg>
        <pc:spChg chg="mod">
          <ac:chgData name="Brian Robinson" userId="0641c4c5-2f89-46b7-a1c0-255ee54644ae" providerId="ADAL" clId="{ED66AB01-BF40-454D-9816-B00C85E3E4E3}" dt="2025-10-21T13:32:50.595" v="35" actId="1076"/>
          <ac:spMkLst>
            <pc:docMk/>
            <pc:sldMk cId="349248455" sldId="257"/>
            <ac:spMk id="3" creationId="{141E4767-9584-5800-2001-4B5E799DCE20}"/>
          </ac:spMkLst>
        </pc:spChg>
        <pc:spChg chg="add mod">
          <ac:chgData name="Brian Robinson" userId="0641c4c5-2f89-46b7-a1c0-255ee54644ae" providerId="ADAL" clId="{ED66AB01-BF40-454D-9816-B00C85E3E4E3}" dt="2025-10-21T14:17:24.422" v="389" actId="14100"/>
          <ac:spMkLst>
            <pc:docMk/>
            <pc:sldMk cId="349248455" sldId="257"/>
            <ac:spMk id="4" creationId="{79CF00A2-2CB6-DB35-B560-27E9DCAFAE8E}"/>
          </ac:spMkLst>
        </pc:spChg>
        <pc:spChg chg="mod">
          <ac:chgData name="Brian Robinson" userId="0641c4c5-2f89-46b7-a1c0-255ee54644ae" providerId="ADAL" clId="{ED66AB01-BF40-454D-9816-B00C85E3E4E3}" dt="2025-10-21T14:17:15.060" v="387" actId="14100"/>
          <ac:spMkLst>
            <pc:docMk/>
            <pc:sldMk cId="349248455" sldId="257"/>
            <ac:spMk id="5" creationId="{DFFB3F8F-A8BF-C626-C958-83749942F071}"/>
          </ac:spMkLst>
        </pc:spChg>
      </pc:sldChg>
      <pc:sldChg chg="addSp modSp mod">
        <pc:chgData name="Brian Robinson" userId="0641c4c5-2f89-46b7-a1c0-255ee54644ae" providerId="ADAL" clId="{ED66AB01-BF40-454D-9816-B00C85E3E4E3}" dt="2025-10-21T17:44:15.804" v="535" actId="1076"/>
        <pc:sldMkLst>
          <pc:docMk/>
          <pc:sldMk cId="2916643703" sldId="258"/>
        </pc:sldMkLst>
        <pc:spChg chg="mod">
          <ac:chgData name="Brian Robinson" userId="0641c4c5-2f89-46b7-a1c0-255ee54644ae" providerId="ADAL" clId="{ED66AB01-BF40-454D-9816-B00C85E3E4E3}" dt="2025-10-21T17:41:52.552" v="480" actId="27636"/>
          <ac:spMkLst>
            <pc:docMk/>
            <pc:sldMk cId="2916643703" sldId="258"/>
            <ac:spMk id="3" creationId="{5188CA69-584E-36DF-2777-F5810BAB2813}"/>
          </ac:spMkLst>
        </pc:spChg>
        <pc:spChg chg="mod">
          <ac:chgData name="Brian Robinson" userId="0641c4c5-2f89-46b7-a1c0-255ee54644ae" providerId="ADAL" clId="{ED66AB01-BF40-454D-9816-B00C85E3E4E3}" dt="2025-10-21T13:52:11.427" v="145" actId="27636"/>
          <ac:spMkLst>
            <pc:docMk/>
            <pc:sldMk cId="2916643703" sldId="258"/>
            <ac:spMk id="4" creationId="{F3B15881-F131-FDEF-D1CC-4E88BB65AA5D}"/>
          </ac:spMkLst>
        </pc:spChg>
        <pc:spChg chg="add mod">
          <ac:chgData name="Brian Robinson" userId="0641c4c5-2f89-46b7-a1c0-255ee54644ae" providerId="ADAL" clId="{ED66AB01-BF40-454D-9816-B00C85E3E4E3}" dt="2025-10-21T17:42:09.553" v="483" actId="14100"/>
          <ac:spMkLst>
            <pc:docMk/>
            <pc:sldMk cId="2916643703" sldId="258"/>
            <ac:spMk id="5" creationId="{FFDBAC9A-1053-EC94-3857-10B34838687B}"/>
          </ac:spMkLst>
        </pc:spChg>
        <pc:picChg chg="add mod">
          <ac:chgData name="Brian Robinson" userId="0641c4c5-2f89-46b7-a1c0-255ee54644ae" providerId="ADAL" clId="{ED66AB01-BF40-454D-9816-B00C85E3E4E3}" dt="2025-10-21T17:44:15.804" v="535" actId="1076"/>
          <ac:picMkLst>
            <pc:docMk/>
            <pc:sldMk cId="2916643703" sldId="258"/>
            <ac:picMk id="7" creationId="{3A08392A-2305-7902-4C04-034C8DD36B90}"/>
          </ac:picMkLst>
        </pc:picChg>
      </pc:sldChg>
      <pc:sldChg chg="modSp mod">
        <pc:chgData name="Brian Robinson" userId="0641c4c5-2f89-46b7-a1c0-255ee54644ae" providerId="ADAL" clId="{ED66AB01-BF40-454D-9816-B00C85E3E4E3}" dt="2025-10-21T14:14:24.955" v="359" actId="255"/>
        <pc:sldMkLst>
          <pc:docMk/>
          <pc:sldMk cId="846788600" sldId="259"/>
        </pc:sldMkLst>
        <pc:spChg chg="mod">
          <ac:chgData name="Brian Robinson" userId="0641c4c5-2f89-46b7-a1c0-255ee54644ae" providerId="ADAL" clId="{ED66AB01-BF40-454D-9816-B00C85E3E4E3}" dt="2025-10-21T13:46:26.421" v="119" actId="1076"/>
          <ac:spMkLst>
            <pc:docMk/>
            <pc:sldMk cId="846788600" sldId="259"/>
            <ac:spMk id="3" creationId="{49966EE5-E4C1-854A-7562-C7CFB9E302CF}"/>
          </ac:spMkLst>
        </pc:spChg>
        <pc:spChg chg="mod">
          <ac:chgData name="Brian Robinson" userId="0641c4c5-2f89-46b7-a1c0-255ee54644ae" providerId="ADAL" clId="{ED66AB01-BF40-454D-9816-B00C85E3E4E3}" dt="2025-10-21T14:14:24.955" v="359" actId="255"/>
          <ac:spMkLst>
            <pc:docMk/>
            <pc:sldMk cId="846788600" sldId="259"/>
            <ac:spMk id="4" creationId="{DD252B29-31BD-1BD9-F5E8-1CBAD4CD965E}"/>
          </ac:spMkLst>
        </pc:spChg>
      </pc:sldChg>
      <pc:sldChg chg="modSp mod">
        <pc:chgData name="Brian Robinson" userId="0641c4c5-2f89-46b7-a1c0-255ee54644ae" providerId="ADAL" clId="{ED66AB01-BF40-454D-9816-B00C85E3E4E3}" dt="2025-10-21T14:14:35.807" v="361" actId="255"/>
        <pc:sldMkLst>
          <pc:docMk/>
          <pc:sldMk cId="61792851" sldId="260"/>
        </pc:sldMkLst>
        <pc:spChg chg="mod">
          <ac:chgData name="Brian Robinson" userId="0641c4c5-2f89-46b7-a1c0-255ee54644ae" providerId="ADAL" clId="{ED66AB01-BF40-454D-9816-B00C85E3E4E3}" dt="2025-10-21T13:46:36.757" v="122" actId="14100"/>
          <ac:spMkLst>
            <pc:docMk/>
            <pc:sldMk cId="61792851" sldId="260"/>
            <ac:spMk id="3" creationId="{BC732F11-9C76-3E79-BA00-66C4293151F9}"/>
          </ac:spMkLst>
        </pc:spChg>
        <pc:spChg chg="mod">
          <ac:chgData name="Brian Robinson" userId="0641c4c5-2f89-46b7-a1c0-255ee54644ae" providerId="ADAL" clId="{ED66AB01-BF40-454D-9816-B00C85E3E4E3}" dt="2025-10-21T14:14:35.807" v="361" actId="255"/>
          <ac:spMkLst>
            <pc:docMk/>
            <pc:sldMk cId="61792851" sldId="260"/>
            <ac:spMk id="4" creationId="{58E518B5-9232-C6F5-75B2-0BB56EAA1758}"/>
          </ac:spMkLst>
        </pc:spChg>
      </pc:sldChg>
      <pc:sldChg chg="modSp mod">
        <pc:chgData name="Brian Robinson" userId="0641c4c5-2f89-46b7-a1c0-255ee54644ae" providerId="ADAL" clId="{ED66AB01-BF40-454D-9816-B00C85E3E4E3}" dt="2025-10-21T14:16:14.891" v="376" actId="14100"/>
        <pc:sldMkLst>
          <pc:docMk/>
          <pc:sldMk cId="3991449731" sldId="261"/>
        </pc:sldMkLst>
        <pc:spChg chg="mod">
          <ac:chgData name="Brian Robinson" userId="0641c4c5-2f89-46b7-a1c0-255ee54644ae" providerId="ADAL" clId="{ED66AB01-BF40-454D-9816-B00C85E3E4E3}" dt="2025-10-21T14:16:14.891" v="376" actId="14100"/>
          <ac:spMkLst>
            <pc:docMk/>
            <pc:sldMk cId="3991449731" sldId="261"/>
            <ac:spMk id="4" creationId="{DBDDA440-BFAD-3CCF-5AD6-A4C11FA1A774}"/>
          </ac:spMkLst>
        </pc:spChg>
      </pc:sldChg>
      <pc:sldChg chg="addSp delSp modSp mod">
        <pc:chgData name="Brian Robinson" userId="0641c4c5-2f89-46b7-a1c0-255ee54644ae" providerId="ADAL" clId="{ED66AB01-BF40-454D-9816-B00C85E3E4E3}" dt="2025-10-21T17:39:53.644" v="459" actId="1076"/>
        <pc:sldMkLst>
          <pc:docMk/>
          <pc:sldMk cId="1096294136" sldId="262"/>
        </pc:sldMkLst>
        <pc:spChg chg="mod">
          <ac:chgData name="Brian Robinson" userId="0641c4c5-2f89-46b7-a1c0-255ee54644ae" providerId="ADAL" clId="{ED66AB01-BF40-454D-9816-B00C85E3E4E3}" dt="2025-10-21T13:53:00.543" v="152" actId="1076"/>
          <ac:spMkLst>
            <pc:docMk/>
            <pc:sldMk cId="1096294136" sldId="262"/>
            <ac:spMk id="2" creationId="{D0C39A04-095D-6466-EAE2-49C0715CB9E2}"/>
          </ac:spMkLst>
        </pc:spChg>
        <pc:spChg chg="mod">
          <ac:chgData name="Brian Robinson" userId="0641c4c5-2f89-46b7-a1c0-255ee54644ae" providerId="ADAL" clId="{ED66AB01-BF40-454D-9816-B00C85E3E4E3}" dt="2025-10-21T13:59:58.571" v="209" actId="947"/>
          <ac:spMkLst>
            <pc:docMk/>
            <pc:sldMk cId="1096294136" sldId="262"/>
            <ac:spMk id="3" creationId="{4E343DDA-D32A-66F6-F258-0722FC491DD2}"/>
          </ac:spMkLst>
        </pc:spChg>
        <pc:spChg chg="mod">
          <ac:chgData name="Brian Robinson" userId="0641c4c5-2f89-46b7-a1c0-255ee54644ae" providerId="ADAL" clId="{ED66AB01-BF40-454D-9816-B00C85E3E4E3}" dt="2025-10-21T14:16:43.192" v="383" actId="1076"/>
          <ac:spMkLst>
            <pc:docMk/>
            <pc:sldMk cId="1096294136" sldId="262"/>
            <ac:spMk id="4" creationId="{70CF0EC7-305A-069F-DE6C-87BAE8FEF3F6}"/>
          </ac:spMkLst>
        </pc:spChg>
        <pc:picChg chg="del mod modCrop">
          <ac:chgData name="Brian Robinson" userId="0641c4c5-2f89-46b7-a1c0-255ee54644ae" providerId="ADAL" clId="{ED66AB01-BF40-454D-9816-B00C85E3E4E3}" dt="2025-10-21T17:39:51.462" v="458" actId="478"/>
          <ac:picMkLst>
            <pc:docMk/>
            <pc:sldMk cId="1096294136" sldId="262"/>
            <ac:picMk id="6" creationId="{B16D7E21-8E16-83C8-BE1D-55F40F238673}"/>
          </ac:picMkLst>
        </pc:picChg>
        <pc:picChg chg="add del mod">
          <ac:chgData name="Brian Robinson" userId="0641c4c5-2f89-46b7-a1c0-255ee54644ae" providerId="ADAL" clId="{ED66AB01-BF40-454D-9816-B00C85E3E4E3}" dt="2025-10-21T17:39:34.487" v="452" actId="478"/>
          <ac:picMkLst>
            <pc:docMk/>
            <pc:sldMk cId="1096294136" sldId="262"/>
            <ac:picMk id="7" creationId="{16219544-36B3-BCD5-14EB-CB37E9E74A46}"/>
          </ac:picMkLst>
        </pc:picChg>
        <pc:picChg chg="add mod">
          <ac:chgData name="Brian Robinson" userId="0641c4c5-2f89-46b7-a1c0-255ee54644ae" providerId="ADAL" clId="{ED66AB01-BF40-454D-9816-B00C85E3E4E3}" dt="2025-10-21T17:39:53.644" v="459" actId="1076"/>
          <ac:picMkLst>
            <pc:docMk/>
            <pc:sldMk cId="1096294136" sldId="262"/>
            <ac:picMk id="9" creationId="{05A41BEC-293D-0256-F108-894C46DB4740}"/>
          </ac:picMkLst>
        </pc:picChg>
      </pc:sldChg>
      <pc:sldChg chg="modSp mod">
        <pc:chgData name="Brian Robinson" userId="0641c4c5-2f89-46b7-a1c0-255ee54644ae" providerId="ADAL" clId="{ED66AB01-BF40-454D-9816-B00C85E3E4E3}" dt="2025-10-21T14:16:50.491" v="384" actId="255"/>
        <pc:sldMkLst>
          <pc:docMk/>
          <pc:sldMk cId="2184952991" sldId="263"/>
        </pc:sldMkLst>
        <pc:spChg chg="mod">
          <ac:chgData name="Brian Robinson" userId="0641c4c5-2f89-46b7-a1c0-255ee54644ae" providerId="ADAL" clId="{ED66AB01-BF40-454D-9816-B00C85E3E4E3}" dt="2025-10-21T13:52:42.349" v="150" actId="20577"/>
          <ac:spMkLst>
            <pc:docMk/>
            <pc:sldMk cId="2184952991" sldId="263"/>
            <ac:spMk id="3" creationId="{815B60DD-0861-1DB5-3398-FF209AFBF044}"/>
          </ac:spMkLst>
        </pc:spChg>
        <pc:spChg chg="mod">
          <ac:chgData name="Brian Robinson" userId="0641c4c5-2f89-46b7-a1c0-255ee54644ae" providerId="ADAL" clId="{ED66AB01-BF40-454D-9816-B00C85E3E4E3}" dt="2025-10-21T14:16:50.491" v="384" actId="255"/>
          <ac:spMkLst>
            <pc:docMk/>
            <pc:sldMk cId="2184952991" sldId="263"/>
            <ac:spMk id="4" creationId="{4E9B8D86-9BAC-97AF-2EC8-D5AB80679118}"/>
          </ac:spMkLst>
        </pc:spChg>
        <pc:spChg chg="mod">
          <ac:chgData name="Brian Robinson" userId="0641c4c5-2f89-46b7-a1c0-255ee54644ae" providerId="ADAL" clId="{ED66AB01-BF40-454D-9816-B00C85E3E4E3}" dt="2025-10-21T13:47:47.104" v="137" actId="14100"/>
          <ac:spMkLst>
            <pc:docMk/>
            <pc:sldMk cId="2184952991" sldId="263"/>
            <ac:spMk id="10" creationId="{60208F02-F87D-F600-2623-03D0DDDEAA37}"/>
          </ac:spMkLst>
        </pc:spChg>
        <pc:picChg chg="mod">
          <ac:chgData name="Brian Robinson" userId="0641c4c5-2f89-46b7-a1c0-255ee54644ae" providerId="ADAL" clId="{ED66AB01-BF40-454D-9816-B00C85E3E4E3}" dt="2025-10-21T13:47:14.112" v="130" actId="1076"/>
          <ac:picMkLst>
            <pc:docMk/>
            <pc:sldMk cId="2184952991" sldId="263"/>
            <ac:picMk id="9" creationId="{DCA585D3-7A65-1858-4000-96151B0FB1DD}"/>
          </ac:picMkLst>
        </pc:picChg>
      </pc:sldChg>
      <pc:sldChg chg="addSp delSp modSp mod">
        <pc:chgData name="Brian Robinson" userId="0641c4c5-2f89-46b7-a1c0-255ee54644ae" providerId="ADAL" clId="{ED66AB01-BF40-454D-9816-B00C85E3E4E3}" dt="2025-10-21T17:33:33.991" v="396" actId="20577"/>
        <pc:sldMkLst>
          <pc:docMk/>
          <pc:sldMk cId="3995532469" sldId="264"/>
        </pc:sldMkLst>
        <pc:spChg chg="mod">
          <ac:chgData name="Brian Robinson" userId="0641c4c5-2f89-46b7-a1c0-255ee54644ae" providerId="ADAL" clId="{ED66AB01-BF40-454D-9816-B00C85E3E4E3}" dt="2025-10-21T17:33:33.991" v="396" actId="20577"/>
          <ac:spMkLst>
            <pc:docMk/>
            <pc:sldMk cId="3995532469" sldId="264"/>
            <ac:spMk id="3" creationId="{26DFE193-2D12-0F2B-5EA1-EB58AD02C51C}"/>
          </ac:spMkLst>
        </pc:spChg>
        <pc:spChg chg="mod">
          <ac:chgData name="Brian Robinson" userId="0641c4c5-2f89-46b7-a1c0-255ee54644ae" providerId="ADAL" clId="{ED66AB01-BF40-454D-9816-B00C85E3E4E3}" dt="2025-10-21T14:15:14.951" v="371" actId="14100"/>
          <ac:spMkLst>
            <pc:docMk/>
            <pc:sldMk cId="3995532469" sldId="264"/>
            <ac:spMk id="4" creationId="{21E7F5EF-D6AA-7E40-287F-85483D02C2F1}"/>
          </ac:spMkLst>
        </pc:spChg>
        <pc:spChg chg="mod">
          <ac:chgData name="Brian Robinson" userId="0641c4c5-2f89-46b7-a1c0-255ee54644ae" providerId="ADAL" clId="{ED66AB01-BF40-454D-9816-B00C85E3E4E3}" dt="2025-10-21T14:04:22.474" v="260" actId="1582"/>
          <ac:spMkLst>
            <pc:docMk/>
            <pc:sldMk cId="3995532469" sldId="264"/>
            <ac:spMk id="12" creationId="{98AE748C-1A6B-8693-B51B-95E2E8117FF6}"/>
          </ac:spMkLst>
        </pc:spChg>
        <pc:spChg chg="add mod">
          <ac:chgData name="Brian Robinson" userId="0641c4c5-2f89-46b7-a1c0-255ee54644ae" providerId="ADAL" clId="{ED66AB01-BF40-454D-9816-B00C85E3E4E3}" dt="2025-10-21T17:33:00.488" v="390" actId="693"/>
          <ac:spMkLst>
            <pc:docMk/>
            <pc:sldMk cId="3995532469" sldId="264"/>
            <ac:spMk id="25" creationId="{7FC9C7F8-8D44-C621-08F9-5A53F6B7BD93}"/>
          </ac:spMkLst>
        </pc:spChg>
        <pc:picChg chg="mod modCrop">
          <ac:chgData name="Brian Robinson" userId="0641c4c5-2f89-46b7-a1c0-255ee54644ae" providerId="ADAL" clId="{ED66AB01-BF40-454D-9816-B00C85E3E4E3}" dt="2025-10-21T14:04:29.586" v="261" actId="14100"/>
          <ac:picMkLst>
            <pc:docMk/>
            <pc:sldMk cId="3995532469" sldId="264"/>
            <ac:picMk id="10" creationId="{2FAD2C4A-0482-C70B-232B-23D3E8E3E16E}"/>
          </ac:picMkLst>
        </pc:picChg>
        <pc:cxnChg chg="add del mod">
          <ac:chgData name="Brian Robinson" userId="0641c4c5-2f89-46b7-a1c0-255ee54644ae" providerId="ADAL" clId="{ED66AB01-BF40-454D-9816-B00C85E3E4E3}" dt="2025-10-21T14:05:02.307" v="265" actId="478"/>
          <ac:cxnSpMkLst>
            <pc:docMk/>
            <pc:sldMk cId="3995532469" sldId="264"/>
            <ac:cxnSpMk id="6" creationId="{256EFD4A-6E88-F36E-5CF3-6135D9110AA6}"/>
          </ac:cxnSpMkLst>
        </pc:cxnChg>
        <pc:cxnChg chg="add del mod">
          <ac:chgData name="Brian Robinson" userId="0641c4c5-2f89-46b7-a1c0-255ee54644ae" providerId="ADAL" clId="{ED66AB01-BF40-454D-9816-B00C85E3E4E3}" dt="2025-10-21T14:05:31.336" v="274" actId="478"/>
          <ac:cxnSpMkLst>
            <pc:docMk/>
            <pc:sldMk cId="3995532469" sldId="264"/>
            <ac:cxnSpMk id="11" creationId="{64369354-6B9E-43DA-6142-FCE1E1C7CCCC}"/>
          </ac:cxnSpMkLst>
        </pc:cxnChg>
        <pc:cxnChg chg="add del mod">
          <ac:chgData name="Brian Robinson" userId="0641c4c5-2f89-46b7-a1c0-255ee54644ae" providerId="ADAL" clId="{ED66AB01-BF40-454D-9816-B00C85E3E4E3}" dt="2025-10-21T14:06:16.778" v="280" actId="478"/>
          <ac:cxnSpMkLst>
            <pc:docMk/>
            <pc:sldMk cId="3995532469" sldId="264"/>
            <ac:cxnSpMk id="21" creationId="{F118207B-B3F8-5D53-AA88-0E9236EE8DB1}"/>
          </ac:cxnSpMkLst>
        </pc:cxnChg>
        <pc:cxnChg chg="add mod">
          <ac:chgData name="Brian Robinson" userId="0641c4c5-2f89-46b7-a1c0-255ee54644ae" providerId="ADAL" clId="{ED66AB01-BF40-454D-9816-B00C85E3E4E3}" dt="2025-10-21T17:33:06.194" v="391" actId="693"/>
          <ac:cxnSpMkLst>
            <pc:docMk/>
            <pc:sldMk cId="3995532469" sldId="264"/>
            <ac:cxnSpMk id="27" creationId="{E8621EBC-80C4-6EF3-F1C5-2A359ACBDA1D}"/>
          </ac:cxnSpMkLst>
        </pc:cxnChg>
      </pc:sldChg>
      <pc:sldChg chg="addSp modSp mod">
        <pc:chgData name="Brian Robinson" userId="0641c4c5-2f89-46b7-a1c0-255ee54644ae" providerId="ADAL" clId="{ED66AB01-BF40-454D-9816-B00C85E3E4E3}" dt="2025-10-21T17:48:21.332" v="556" actId="1076"/>
        <pc:sldMkLst>
          <pc:docMk/>
          <pc:sldMk cId="3467417185" sldId="265"/>
        </pc:sldMkLst>
        <pc:spChg chg="mod">
          <ac:chgData name="Brian Robinson" userId="0641c4c5-2f89-46b7-a1c0-255ee54644ae" providerId="ADAL" clId="{ED66AB01-BF40-454D-9816-B00C85E3E4E3}" dt="2025-10-21T14:10:22.096" v="339" actId="1076"/>
          <ac:spMkLst>
            <pc:docMk/>
            <pc:sldMk cId="3467417185" sldId="265"/>
            <ac:spMk id="2" creationId="{45249FC6-EDFC-4C95-549E-DEC1BFC95C14}"/>
          </ac:spMkLst>
        </pc:spChg>
        <pc:spChg chg="mod">
          <ac:chgData name="Brian Robinson" userId="0641c4c5-2f89-46b7-a1c0-255ee54644ae" providerId="ADAL" clId="{ED66AB01-BF40-454D-9816-B00C85E3E4E3}" dt="2025-10-21T17:48:21.332" v="556" actId="1076"/>
          <ac:spMkLst>
            <pc:docMk/>
            <pc:sldMk cId="3467417185" sldId="265"/>
            <ac:spMk id="3" creationId="{AF638576-5B91-19E1-8CEC-3FCCF12B2F2B}"/>
          </ac:spMkLst>
        </pc:spChg>
        <pc:spChg chg="mod">
          <ac:chgData name="Brian Robinson" userId="0641c4c5-2f89-46b7-a1c0-255ee54644ae" providerId="ADAL" clId="{ED66AB01-BF40-454D-9816-B00C85E3E4E3}" dt="2025-10-21T17:46:33.972" v="544" actId="1076"/>
          <ac:spMkLst>
            <pc:docMk/>
            <pc:sldMk cId="3467417185" sldId="265"/>
            <ac:spMk id="4" creationId="{DA0C7128-478B-17E9-E1AA-FD59DCD58889}"/>
          </ac:spMkLst>
        </pc:spChg>
        <pc:spChg chg="mod">
          <ac:chgData name="Brian Robinson" userId="0641c4c5-2f89-46b7-a1c0-255ee54644ae" providerId="ADAL" clId="{ED66AB01-BF40-454D-9816-B00C85E3E4E3}" dt="2025-10-21T17:37:04.878" v="437" actId="20577"/>
          <ac:spMkLst>
            <pc:docMk/>
            <pc:sldMk cId="3467417185" sldId="265"/>
            <ac:spMk id="7" creationId="{2F649B7F-BC82-4FC5-BE25-AE828F5CAC8D}"/>
          </ac:spMkLst>
        </pc:spChg>
        <pc:spChg chg="add mod ord">
          <ac:chgData name="Brian Robinson" userId="0641c4c5-2f89-46b7-a1c0-255ee54644ae" providerId="ADAL" clId="{ED66AB01-BF40-454D-9816-B00C85E3E4E3}" dt="2025-10-21T17:46:59.060" v="550" actId="167"/>
          <ac:spMkLst>
            <pc:docMk/>
            <pc:sldMk cId="3467417185" sldId="265"/>
            <ac:spMk id="9" creationId="{B0733C3F-D180-A2BE-ACA7-9EC3878B6C24}"/>
          </ac:spMkLst>
        </pc:spChg>
        <pc:picChg chg="mod">
          <ac:chgData name="Brian Robinson" userId="0641c4c5-2f89-46b7-a1c0-255ee54644ae" providerId="ADAL" clId="{ED66AB01-BF40-454D-9816-B00C85E3E4E3}" dt="2025-10-21T14:10:25.408" v="340" actId="14100"/>
          <ac:picMkLst>
            <pc:docMk/>
            <pc:sldMk cId="3467417185" sldId="265"/>
            <ac:picMk id="6" creationId="{BE2BFCC7-3E6F-0D84-1426-5511076646A5}"/>
          </ac:picMkLst>
        </pc:picChg>
        <pc:picChg chg="add mod">
          <ac:chgData name="Brian Robinson" userId="0641c4c5-2f89-46b7-a1c0-255ee54644ae" providerId="ADAL" clId="{ED66AB01-BF40-454D-9816-B00C85E3E4E3}" dt="2025-10-21T17:47:07.149" v="551" actId="14100"/>
          <ac:picMkLst>
            <pc:docMk/>
            <pc:sldMk cId="3467417185" sldId="265"/>
            <ac:picMk id="8" creationId="{FAC582FD-3549-541A-C2C4-99FD82A367D5}"/>
          </ac:picMkLst>
        </pc:picChg>
      </pc:sldChg>
      <pc:sldChg chg="modSp mod">
        <pc:chgData name="Brian Robinson" userId="0641c4c5-2f89-46b7-a1c0-255ee54644ae" providerId="ADAL" clId="{ED66AB01-BF40-454D-9816-B00C85E3E4E3}" dt="2025-10-21T17:47:59.206" v="555" actId="113"/>
        <pc:sldMkLst>
          <pc:docMk/>
          <pc:sldMk cId="2986768578" sldId="266"/>
        </pc:sldMkLst>
        <pc:spChg chg="mod">
          <ac:chgData name="Brian Robinson" userId="0641c4c5-2f89-46b7-a1c0-255ee54644ae" providerId="ADAL" clId="{ED66AB01-BF40-454D-9816-B00C85E3E4E3}" dt="2025-10-21T17:47:59.206" v="555" actId="113"/>
          <ac:spMkLst>
            <pc:docMk/>
            <pc:sldMk cId="2986768578" sldId="266"/>
            <ac:spMk id="3" creationId="{0570F3C1-4EAA-F0D2-D2E0-9BE405963C0F}"/>
          </ac:spMkLst>
        </pc:spChg>
        <pc:spChg chg="mod">
          <ac:chgData name="Brian Robinson" userId="0641c4c5-2f89-46b7-a1c0-255ee54644ae" providerId="ADAL" clId="{ED66AB01-BF40-454D-9816-B00C85E3E4E3}" dt="2025-10-21T14:15:20.186" v="373" actId="27636"/>
          <ac:spMkLst>
            <pc:docMk/>
            <pc:sldMk cId="2986768578" sldId="266"/>
            <ac:spMk id="4" creationId="{DE188AC0-B3CD-251F-8315-B49837FAEEC1}"/>
          </ac:spMkLst>
        </pc:spChg>
        <pc:spChg chg="mod">
          <ac:chgData name="Brian Robinson" userId="0641c4c5-2f89-46b7-a1c0-255ee54644ae" providerId="ADAL" clId="{ED66AB01-BF40-454D-9816-B00C85E3E4E3}" dt="2025-10-21T14:09:29.331" v="323" actId="403"/>
          <ac:spMkLst>
            <pc:docMk/>
            <pc:sldMk cId="2986768578" sldId="266"/>
            <ac:spMk id="9" creationId="{4834DCFA-1B94-4901-28F6-8D1436F71496}"/>
          </ac:spMkLst>
        </pc:spChg>
        <pc:picChg chg="mod">
          <ac:chgData name="Brian Robinson" userId="0641c4c5-2f89-46b7-a1c0-255ee54644ae" providerId="ADAL" clId="{ED66AB01-BF40-454D-9816-B00C85E3E4E3}" dt="2025-10-21T14:09:12.424" v="309" actId="1076"/>
          <ac:picMkLst>
            <pc:docMk/>
            <pc:sldMk cId="2986768578" sldId="266"/>
            <ac:picMk id="8" creationId="{04C9002A-44A6-36B6-AE40-E8996F2552DC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484EE-1AFA-37AE-0DBB-9AE06E4323C1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1149178" y="2235200"/>
            <a:ext cx="10243752" cy="2387600"/>
          </a:xfrm>
        </p:spPr>
        <p:txBody>
          <a:bodyPr anchor="b">
            <a:normAutofit/>
          </a:bodyPr>
          <a:lstStyle>
            <a:lvl1pPr algn="r">
              <a:defRPr sz="540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tle of Journal Club Featur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4CDBF9-AE24-B1A3-9703-BA6F3EE632E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1149178" y="4714875"/>
            <a:ext cx="10243752" cy="1204740"/>
          </a:xfrm>
        </p:spPr>
        <p:txBody>
          <a:bodyPr/>
          <a:lstStyle>
            <a:lvl1pPr marL="0" indent="0" algn="r">
              <a:buNone/>
              <a:defRPr sz="24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Author(s) </a:t>
            </a:r>
            <a:r>
              <a:rPr lang="en-US"/>
              <a:t>of journal </a:t>
            </a:r>
            <a:r>
              <a:rPr lang="en-US" dirty="0"/>
              <a:t>club materials</a:t>
            </a:r>
          </a:p>
        </p:txBody>
      </p:sp>
    </p:spTree>
    <p:extLst>
      <p:ext uri="{BB962C8B-B14F-4D97-AF65-F5344CB8AC3E}">
        <p14:creationId xmlns:p14="http://schemas.microsoft.com/office/powerpoint/2010/main" val="2197976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ackgroun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26CAB3-D7F9-CD46-7A75-4ECC353AE8F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28135" y="1581674"/>
            <a:ext cx="11073714" cy="936901"/>
          </a:xfrm>
        </p:spPr>
        <p:txBody>
          <a:bodyPr/>
          <a:lstStyle/>
          <a:p>
            <a:r>
              <a:rPr lang="en-US" dirty="0"/>
              <a:t>Backgr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36C866-60DA-3E92-9A04-72D65FC80DAB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28135" y="2632284"/>
            <a:ext cx="11073714" cy="3527806"/>
          </a:xfrm>
        </p:spPr>
        <p:txBody>
          <a:bodyPr>
            <a:normAutofit/>
          </a:bodyPr>
          <a:lstStyle>
            <a:lvl1pPr>
              <a:defRPr sz="2400"/>
            </a:lvl1pPr>
          </a:lstStyle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dirty="0"/>
              <a:t>Short summary of the purpose of </a:t>
            </a:r>
            <a:r>
              <a:rPr lang="en-US"/>
              <a:t>the article. Include any key prior studies that informed or led to this work, along with citations</a:t>
            </a:r>
          </a:p>
          <a:p>
            <a:pPr lvl="0"/>
            <a:endParaRPr lang="en-US" dirty="0"/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162F113-14A5-93CA-018A-018B7888E2C2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2325852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etho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Methods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4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lvl="0"/>
            <a:r>
              <a:rPr lang="en-US" dirty="0"/>
              <a:t>Brief summary of the data source, study design (e.g. randomized trial, observational cohort study, cross-sectional study), and any aspects of analysis or statistical methods that are important to understanding the study (including why these methods were chosen to answer this question)</a:t>
            </a:r>
          </a:p>
        </p:txBody>
      </p:sp>
      <p:sp>
        <p:nvSpPr>
          <p:cNvPr id="9" name="Text Placeholder 7">
            <a:extLst>
              <a:ext uri="{FF2B5EF4-FFF2-40B4-BE49-F238E27FC236}">
                <a16:creationId xmlns:a16="http://schemas.microsoft.com/office/drawing/2014/main" id="{EFD5A073-AD13-5D77-451D-FE4D472EE441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80599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sul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Results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4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dirty="0"/>
              <a:t>Key table(s) and figure(s) along with bullet points with </a:t>
            </a:r>
            <a:r>
              <a:rPr lang="en-US"/>
              <a:t>key findings. (If you need an additional slide, please duplicate this slide)</a:t>
            </a:r>
          </a:p>
          <a:p>
            <a:pPr lvl="0"/>
            <a:endParaRPr lang="en-US" dirty="0"/>
          </a:p>
        </p:txBody>
      </p:sp>
      <p:sp>
        <p:nvSpPr>
          <p:cNvPr id="2" name="Text Placeholder 7">
            <a:extLst>
              <a:ext uri="{FF2B5EF4-FFF2-40B4-BE49-F238E27FC236}">
                <a16:creationId xmlns:a16="http://schemas.microsoft.com/office/drawing/2014/main" id="{F0BB15E5-B5B2-5635-5CE7-88D5AD839AC2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3510468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scuss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Placeholder 1">
            <a:extLst>
              <a:ext uri="{FF2B5EF4-FFF2-40B4-BE49-F238E27FC236}">
                <a16:creationId xmlns:a16="http://schemas.microsoft.com/office/drawing/2014/main" id="{D9C38295-B396-7CBD-7C98-37C7326530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05481" y="158167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Discussion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AC610B3-0212-A329-7291-490D3ED54448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605481" y="2632285"/>
            <a:ext cx="11071654" cy="16705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>
              <a:defRPr sz="2400"/>
            </a:lvl1pPr>
          </a:lstStyle>
          <a:p>
            <a:pPr lvl="0"/>
            <a:r>
              <a:rPr lang="en-US" dirty="0"/>
              <a:t>Strengths and weaknesses to consider, including generalizability, potential biases, potential for confounding</a:t>
            </a:r>
          </a:p>
          <a:p>
            <a:pPr lvl="0"/>
            <a:endParaRPr lang="en-US" dirty="0"/>
          </a:p>
        </p:txBody>
      </p:sp>
      <p:sp>
        <p:nvSpPr>
          <p:cNvPr id="2" name="Text Placeholder 7">
            <a:extLst>
              <a:ext uri="{FF2B5EF4-FFF2-40B4-BE49-F238E27FC236}">
                <a16:creationId xmlns:a16="http://schemas.microsoft.com/office/drawing/2014/main" id="{74F97A62-F9D7-F04E-930C-AD37311B155F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28650" y="6178550"/>
            <a:ext cx="11072813" cy="568325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pPr lvl="0"/>
            <a:r>
              <a:rPr lang="en-US" dirty="0"/>
              <a:t>First author, second author, third author, et al. Title. Arthritis Care Res (Hoboken) 202X.</a:t>
            </a:r>
          </a:p>
        </p:txBody>
      </p:sp>
    </p:spTree>
    <p:extLst>
      <p:ext uri="{BB962C8B-B14F-4D97-AF65-F5344CB8AC3E}">
        <p14:creationId xmlns:p14="http://schemas.microsoft.com/office/powerpoint/2010/main" val="1359233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15265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8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537520-D36E-B475-A8EC-7BB4AE348D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81" y="1627394"/>
            <a:ext cx="11071654" cy="936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1701BA-94E3-525E-7C81-CFF551A73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5481" y="2650572"/>
            <a:ext cx="11071654" cy="3084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24578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60" r:id="rId4"/>
    <p:sldLayoutId id="2147483661" r:id="rId5"/>
    <p:sldLayoutId id="2147483662" r:id="rId6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1" i="0" kern="1200" spc="-150">
          <a:solidFill>
            <a:srgbClr val="7030A0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02/acr.25611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Relationship Id="rId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8A319-0C10-171B-BB90-693E0C4557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69806" y="2235199"/>
            <a:ext cx="9623124" cy="2837437"/>
          </a:xfrm>
        </p:spPr>
        <p:txBody>
          <a:bodyPr>
            <a:normAutofit/>
          </a:bodyPr>
          <a:lstStyle/>
          <a:p>
            <a:r>
              <a:rPr lang="en-US" sz="4400"/>
              <a:t>Treating Lupus Nephritis Patients to Lupus Low Disease Activity Reduces Renal Relapse and </a:t>
            </a:r>
            <a:r>
              <a:rPr lang="en-US" sz="4900"/>
              <a:t>Preserves</a:t>
            </a:r>
            <a:r>
              <a:rPr lang="en-US" sz="4400"/>
              <a:t> Long-Term Kidney Function</a:t>
            </a:r>
            <a:endParaRPr lang="en-US" sz="4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1E4767-9584-5800-2001-4B5E799DCE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8406" y="5072636"/>
            <a:ext cx="10243752" cy="645268"/>
          </a:xfrm>
        </p:spPr>
        <p:txBody>
          <a:bodyPr/>
          <a:lstStyle/>
          <a:p>
            <a:r>
              <a:rPr lang="en-US"/>
              <a:t>Chak Kwan Cheung, Shirley CW Chan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FB3F8F-A8BF-C626-C958-83749942F071}"/>
              </a:ext>
            </a:extLst>
          </p:cNvPr>
          <p:cNvSpPr txBox="1">
            <a:spLocks/>
          </p:cNvSpPr>
          <p:nvPr/>
        </p:nvSpPr>
        <p:spPr>
          <a:xfrm>
            <a:off x="943897" y="5918943"/>
            <a:ext cx="10448647" cy="75423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buFont typeface="Arial" panose="020B0604020202020204" pitchFamily="34" charset="0"/>
              <a:buNone/>
              <a:defRPr sz="1200" kern="120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2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US" sz="1600" dirty="0"/>
              <a:t>A feature designed to facilitate discussion of published research. This journal club accompanies the below article:</a:t>
            </a:r>
          </a:p>
          <a:p>
            <a:r>
              <a:rPr lang="en-US" sz="1400" dirty="0"/>
              <a:t>Cheung CK, Yap DY, Lee KL, et al. Treating lupus nephritis patients to lupus low disease activity reduces renal relapse and preserves long-term kidney function. Arthritis Care Res (Hoboken) 2025</a:t>
            </a:r>
            <a:r>
              <a:rPr lang="en-US" sz="1400"/>
              <a:t>. https://doi.org/10.1002/acr.25611</a:t>
            </a:r>
            <a:endParaRPr lang="en-US" sz="1400" dirty="0"/>
          </a:p>
        </p:txBody>
      </p:sp>
      <p:sp>
        <p:nvSpPr>
          <p:cNvPr id="4" name="Rectangle 3">
            <a:hlinkClick r:id="rId2"/>
            <a:extLst>
              <a:ext uri="{FF2B5EF4-FFF2-40B4-BE49-F238E27FC236}">
                <a16:creationId xmlns:a16="http://schemas.microsoft.com/office/drawing/2014/main" id="{79CF00A2-2CB6-DB35-B560-27E9DCAFAE8E}"/>
              </a:ext>
            </a:extLst>
          </p:cNvPr>
          <p:cNvSpPr/>
          <p:nvPr/>
        </p:nvSpPr>
        <p:spPr>
          <a:xfrm>
            <a:off x="943897" y="5918942"/>
            <a:ext cx="10304206" cy="7542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484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4C2DE-DFF4-036A-0623-3394DB34C3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2804B-BC7B-8520-7C8D-9E6D9649D6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632285"/>
            <a:ext cx="11071654" cy="1707141"/>
          </a:xfrm>
        </p:spPr>
        <p:txBody>
          <a:bodyPr>
            <a:normAutofit lnSpcReduction="10000"/>
          </a:bodyPr>
          <a:lstStyle/>
          <a:p>
            <a:r>
              <a:rPr lang="en-US" dirty="0"/>
              <a:t>This study provides evidence of LLDAS as an attainable treatment target in LN. The attainment of LLDAS alone or complementary to CRR/PRR was associated with a reduced risk of LN relapse.</a:t>
            </a:r>
          </a:p>
          <a:p>
            <a:r>
              <a:rPr lang="en-US" dirty="0"/>
              <a:t>Only Chinse patients were included in our cohorts and further studies are needed to confirm the generalizability for patients of various backgrounds. </a:t>
            </a:r>
          </a:p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DDA440-BFAD-3CCF-5AD6-A4C11FA1A77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55750"/>
            <a:ext cx="11072813" cy="391125"/>
          </a:xfrm>
        </p:spPr>
        <p:txBody>
          <a:bodyPr>
            <a:noAutofit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sp>
        <p:nvSpPr>
          <p:cNvPr id="5" name="Text Placeholder 2">
            <a:extLst>
              <a:ext uri="{FF2B5EF4-FFF2-40B4-BE49-F238E27FC236}">
                <a16:creationId xmlns:a16="http://schemas.microsoft.com/office/drawing/2014/main" id="{2C9C66A4-9900-7A74-4396-E5239C7C6389}"/>
              </a:ext>
            </a:extLst>
          </p:cNvPr>
          <p:cNvSpPr txBox="1">
            <a:spLocks/>
          </p:cNvSpPr>
          <p:nvPr/>
        </p:nvSpPr>
        <p:spPr>
          <a:xfrm>
            <a:off x="605481" y="4419472"/>
            <a:ext cx="11071654" cy="18562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Discussion questions:</a:t>
            </a:r>
          </a:p>
          <a:p>
            <a:pPr lvl="1"/>
            <a:r>
              <a:rPr lang="en-US" dirty="0"/>
              <a:t>Implications of results for clinical practice</a:t>
            </a:r>
          </a:p>
          <a:p>
            <a:pPr lvl="1"/>
            <a:r>
              <a:rPr lang="en-US" dirty="0"/>
              <a:t>How do the results apply to patients you see?</a:t>
            </a:r>
          </a:p>
          <a:p>
            <a:pPr lvl="1"/>
            <a:r>
              <a:rPr lang="en-US" dirty="0"/>
              <a:t>Will the results change the way that you care for patients with the condition?</a:t>
            </a:r>
          </a:p>
          <a:p>
            <a:pPr lvl="1"/>
            <a:r>
              <a:rPr lang="en-US" dirty="0"/>
              <a:t>Key next research steps</a:t>
            </a:r>
          </a:p>
        </p:txBody>
      </p:sp>
    </p:spTree>
    <p:extLst>
      <p:ext uri="{BB962C8B-B14F-4D97-AF65-F5344CB8AC3E}">
        <p14:creationId xmlns:p14="http://schemas.microsoft.com/office/powerpoint/2010/main" val="3991449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11B74-DB9C-2DE8-107A-032556819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ckgr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88CA69-584E-36DF-2777-F5810BAB28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135" y="2518574"/>
            <a:ext cx="11073714" cy="3724909"/>
          </a:xfrm>
        </p:spPr>
        <p:txBody>
          <a:bodyPr>
            <a:normAutofit/>
          </a:bodyPr>
          <a:lstStyle/>
          <a:p>
            <a:pPr marL="0" indent="0">
              <a:buNone/>
            </a:pPr>
            <a:endParaRPr lang="en-HK" sz="2800">
              <a:solidFill>
                <a:srgbClr val="212121"/>
              </a:solidFill>
              <a:highlight>
                <a:srgbClr val="FFFFFF"/>
              </a:highlight>
              <a:latin typeface="BlinkMacSystemFont"/>
            </a:endParaRPr>
          </a:p>
          <a:p>
            <a:pPr marL="0" indent="0">
              <a:buNone/>
            </a:pPr>
            <a:endParaRPr lang="en-HK" sz="2800" b="0" i="0" u="none" strike="noStrike">
              <a:solidFill>
                <a:srgbClr val="212121"/>
              </a:solidFill>
              <a:effectLst/>
              <a:highlight>
                <a:srgbClr val="FFFFFF"/>
              </a:highlight>
              <a:latin typeface="BlinkMacSystemFont"/>
            </a:endParaRPr>
          </a:p>
          <a:p>
            <a:pPr marL="0" indent="0">
              <a:buNone/>
            </a:pP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 </a:t>
            </a:r>
            <a:endParaRPr lang="en-HK" sz="2800" b="0" i="0" u="none" strike="noStrike" dirty="0">
              <a:solidFill>
                <a:srgbClr val="212121"/>
              </a:solidFill>
              <a:effectLst/>
              <a:highlight>
                <a:srgbClr val="FFFFFF"/>
              </a:highlight>
              <a:latin typeface="BlinkMacSystemFont"/>
            </a:endParaRP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Lupus low disease activity state (LLDAS) is a validated treatment target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in SLE,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but limited studies have explored the role of LLDAS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in LN. </a:t>
            </a:r>
            <a:endParaRPr lang="en-HK" sz="2800" b="0" i="0" u="none" strike="noStrike" dirty="0">
              <a:solidFill>
                <a:srgbClr val="212121"/>
              </a:solidFill>
              <a:effectLst/>
              <a:highlight>
                <a:srgbClr val="FFFFFF"/>
              </a:highlight>
              <a:latin typeface="BlinkMacSystemFont"/>
            </a:endParaRP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This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study aimed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to investigate the frequency and predictors of LLDAS attainment, and its benefit on LN relapse and renal function preservation in patients with LN.</a:t>
            </a:r>
            <a:endParaRPr lang="en-US" sz="28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B15881-F131-FDEF-D1CC-4E88BB65AA5D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52161"/>
            <a:ext cx="11072813" cy="454788"/>
          </a:xfrm>
        </p:spPr>
        <p:txBody>
          <a:bodyPr>
            <a:normAutofit lnSpcReduction="10000"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FFDBAC9A-1053-EC94-3857-10B34838687B}"/>
              </a:ext>
            </a:extLst>
          </p:cNvPr>
          <p:cNvSpPr txBox="1">
            <a:spLocks/>
          </p:cNvSpPr>
          <p:nvPr/>
        </p:nvSpPr>
        <p:spPr>
          <a:xfrm>
            <a:off x="628134" y="2409896"/>
            <a:ext cx="9282781" cy="35278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ts val="0"/>
              </a:spcBef>
            </a:pPr>
            <a:r>
              <a:rPr lang="en-HK" sz="2800">
                <a:solidFill>
                  <a:srgbClr val="212121"/>
                </a:solidFill>
                <a:highlight>
                  <a:srgbClr val="FFFFFF"/>
                </a:highlight>
                <a:latin typeface="BlinkMacSystemFont"/>
              </a:rPr>
              <a:t>Lupus nephritis (LN) is an important manifestation in up to 50% of patients with systemic lupus erythematosus (SLE). Current LN treatment targets emphasize biochemical data such as proteinuria and serum creatinine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A08392A-2305-7902-4C04-034C8DD36B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4508" b="95848" l="3458" r="93361">
                        <a14:foregroundMark x1="46611" y1="10083" x2="39557" y2="9964"/>
                        <a14:foregroundMark x1="41079" y1="9609" x2="40387" y2="8778"/>
                        <a14:foregroundMark x1="39834" y1="7829" x2="44537" y2="7829"/>
                        <a14:foregroundMark x1="11065" y1="25504" x2="6224" y2="73191"/>
                        <a14:foregroundMark x1="4011" y1="52195" x2="5118" y2="64769"/>
                        <a14:foregroundMark x1="3458" y1="51957" x2="10373" y2="74970"/>
                        <a14:foregroundMark x1="8299" y1="74614" x2="37206" y2="85647"/>
                        <a14:foregroundMark x1="37206" y1="85647" x2="38174" y2="85291"/>
                        <a14:foregroundMark x1="55463" y1="76750" x2="27248" y2="90154"/>
                        <a14:foregroundMark x1="27248" y1="90154" x2="6916" y2="76038"/>
                        <a14:foregroundMark x1="6916" y1="76038" x2="3458" y2="70819"/>
                        <a14:foregroundMark x1="79530" y1="46501" x2="79530" y2="46501"/>
                        <a14:foregroundMark x1="79668" y1="46501" x2="81604" y2="46501"/>
                        <a14:foregroundMark x1="81604" y1="46501" x2="81604" y2="46501"/>
                        <a14:foregroundMark x1="64730" y1="89680" x2="64592" y2="95730"/>
                        <a14:foregroundMark x1="80221" y1="46145" x2="83679" y2="46026"/>
                        <a14:foregroundMark x1="72061" y1="51957" x2="75380" y2="51957"/>
                        <a14:foregroundMark x1="75519" y1="51957" x2="74827" y2="53025"/>
                        <a14:foregroundMark x1="75657" y1="54211" x2="75657" y2="51601"/>
                        <a14:foregroundMark x1="82434" y1="12337" x2="80360" y2="13167"/>
                        <a14:foregroundMark x1="85892" y1="28233" x2="85477" y2="29419"/>
                        <a14:foregroundMark x1="73997" y1="29537" x2="73997" y2="29537"/>
                        <a14:foregroundMark x1="74412" y1="27758" x2="76210" y2="30130"/>
                        <a14:foregroundMark x1="74965" y1="26453" x2="76487" y2="32028"/>
                        <a14:foregroundMark x1="93499" y1="37960" x2="90871" y2="23606"/>
                        <a14:foregroundMark x1="90041" y1="22064" x2="83264" y2="17675"/>
                        <a14:foregroundMark x1="80221" y1="17556" x2="68603" y2="14591"/>
                        <a14:foregroundMark x1="68603" y1="13049" x2="74965" y2="9371"/>
                        <a14:foregroundMark x1="81743" y1="8778" x2="86030" y2="5219"/>
                        <a14:foregroundMark x1="85062" y1="4508" x2="76349" y2="6999"/>
                        <a14:foregroundMark x1="87552" y1="6880" x2="85062" y2="9253"/>
                        <a14:foregroundMark x1="82019" y1="5101" x2="68188" y2="13167"/>
                        <a14:foregroundMark x1="68050" y1="13049" x2="71923" y2="16726"/>
                        <a14:foregroundMark x1="83402" y1="28826" x2="88935" y2="38197"/>
                        <a14:foregroundMark x1="89212" y1="31435" x2="85062" y2="34757"/>
                        <a14:foregroundMark x1="88520" y1="38197" x2="84647" y2="36773"/>
                        <a14:foregroundMark x1="90871" y1="25504" x2="91148" y2="23013"/>
                        <a14:foregroundMark x1="90871" y1="24081" x2="91978" y2="20285"/>
                        <a14:foregroundMark x1="83679" y1="44721" x2="83264" y2="46856"/>
                        <a14:foregroundMark x1="66390" y1="95848" x2="62932" y2="95730"/>
                        <a14:foregroundMark x1="83126" y1="44247" x2="82988" y2="47805"/>
                        <a14:foregroundMark x1="82711" y1="44958" x2="83402" y2="47687"/>
                        <a14:foregroundMark x1="84371" y1="45077" x2="83679" y2="48517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793052" y="1995437"/>
            <a:ext cx="1770813" cy="2064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6643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7DA40-E0DF-460C-1B26-E792F9851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tho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966EE5-E4C1-854A-7562-C7CFB9E302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518575"/>
            <a:ext cx="11071654" cy="3084305"/>
          </a:xfrm>
        </p:spPr>
        <p:txBody>
          <a:bodyPr>
            <a:normAutofit lnSpcReduction="10000"/>
          </a:bodyPr>
          <a:lstStyle/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Patients with LN during 2010-2020 in Queen Mary Hospital and Pamela Youde </a:t>
            </a:r>
            <a:r>
              <a:rPr lang="en-HK" sz="2800" b="0" i="0" u="none" strike="noStrike" dirty="0" err="1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Nethersole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Eastern Hospital, Hong Kong,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were included in the discovery cohort and validation cohort, respectively. </a:t>
            </a: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omplete renal response (CRR), partial renal response (PRR), LLDAS, and DORIS remission were assessed at 12 months. </a:t>
            </a: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Regression analysis was performed to identify risk factors of LN relapse. Receiver operating characteristic (ROC) curves were used to evaluate target attainment and long-term kidney function.</a:t>
            </a:r>
            <a:endParaRPr lang="en-US" sz="28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252B29-31BD-1BD9-F5E8-1CBAD4CD965E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42434"/>
            <a:ext cx="11072813" cy="404441"/>
          </a:xfrm>
        </p:spPr>
        <p:txBody>
          <a:bodyPr>
            <a:noAutofit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467886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94899-5F70-89D8-064D-ED338F694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ults (I) – Attainabi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732F11-9C76-3E79-BA00-66C4293151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632284"/>
            <a:ext cx="10868764" cy="3084305"/>
          </a:xfrm>
        </p:spPr>
        <p:txBody>
          <a:bodyPr>
            <a:normAutofit/>
          </a:bodyPr>
          <a:lstStyle/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A total of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245 patients with LN (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discovery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ohort n=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143, validation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ohort n=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102) were included.</a:t>
            </a: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At 12 months, 57/143 (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40%) achieved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RR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and </a:t>
            </a:r>
            <a:r>
              <a:rPr lang="en-HK" sz="2800">
                <a:solidFill>
                  <a:srgbClr val="212121"/>
                </a:solidFill>
                <a:highlight>
                  <a:srgbClr val="FFFFFF"/>
                </a:highlight>
                <a:latin typeface="BlinkMacSystemFont"/>
              </a:rPr>
              <a:t>14/143 (10%) achieved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PRR in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the discovery cohort. 71/143 (50%) patients attained CRR/PRR.</a:t>
            </a:r>
          </a:p>
          <a:p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70/143 (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49%) and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15/143 (10%) patients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achieved LLDAS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and </a:t>
            </a:r>
            <a:r>
              <a:rPr lang="en-HK" sz="28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DORIS remission, </a:t>
            </a:r>
            <a:r>
              <a:rPr lang="en-HK" sz="28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respectively.</a:t>
            </a:r>
            <a:endParaRPr lang="en-US" sz="2800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E518B5-9232-C6F5-75B2-0BB56EAA175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42434"/>
            <a:ext cx="11072813" cy="404441"/>
          </a:xfrm>
        </p:spPr>
        <p:txBody>
          <a:bodyPr>
            <a:noAutofit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61792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F4961D-6521-B0DF-B8C7-50D1201320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ults (II) – Predicto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5B60DD-0861-1DB5-3398-FF209AFBF0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632284"/>
            <a:ext cx="6119784" cy="3084305"/>
          </a:xfrm>
        </p:spPr>
        <p:txBody>
          <a:bodyPr/>
          <a:lstStyle/>
          <a:p>
            <a:r>
              <a:rPr lang="en-US" dirty="0"/>
              <a:t>In the multivariable analysis, anti-</a:t>
            </a:r>
            <a:r>
              <a:rPr lang="en-US" dirty="0" err="1"/>
              <a:t>Sm</a:t>
            </a:r>
            <a:r>
              <a:rPr lang="en-US" dirty="0"/>
              <a:t> positivity was a significant negative predictor of LLDAS attainment (</a:t>
            </a:r>
            <a:r>
              <a:rPr lang="en-US"/>
              <a:t>adjusted OR </a:t>
            </a:r>
            <a:r>
              <a:rPr lang="en-US" dirty="0"/>
              <a:t>0.33; 95% </a:t>
            </a:r>
            <a:r>
              <a:rPr lang="en-US"/>
              <a:t>CI 0.13–0.86, </a:t>
            </a:r>
            <a:r>
              <a:rPr lang="en-US" i="1"/>
              <a:t>P </a:t>
            </a:r>
            <a:r>
              <a:rPr lang="en-US"/>
              <a:t>= 0.024</a:t>
            </a:r>
            <a:r>
              <a:rPr lang="en-US" dirty="0"/>
              <a:t>). </a:t>
            </a:r>
          </a:p>
          <a:p>
            <a:r>
              <a:rPr lang="en-US" dirty="0"/>
              <a:t>Other variables showed no association with LLDAS attainment, including age, sex, histological class, proteinuria, serum creatinine, and choice of induction agents.</a:t>
            </a:r>
          </a:p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9B8D86-9BAC-97AF-2EC8-D5AB80679118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61993"/>
            <a:ext cx="10550627" cy="384881"/>
          </a:xfrm>
        </p:spPr>
        <p:txBody>
          <a:bodyPr>
            <a:noAutofit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</a:t>
            </a:r>
            <a:r>
              <a:rPr lang="en-HK" sz="14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function. </a:t>
            </a:r>
            <a:r>
              <a:rPr lang="en-HK" sz="1400" b="0" i="1" u="none" strike="noStrike">
                <a:solidFill>
                  <a:srgbClr val="212121"/>
                </a:solidFill>
                <a:effectLst/>
                <a:latin typeface="BlinkMacSystemFont"/>
              </a:rPr>
              <a:t>Arthritis 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pic>
        <p:nvPicPr>
          <p:cNvPr id="9" name="Picture 8" descr="A table of numbers and symbols&#10;&#10;Description automatically generated with medium confidence">
            <a:extLst>
              <a:ext uri="{FF2B5EF4-FFF2-40B4-BE49-F238E27FC236}">
                <a16:creationId xmlns:a16="http://schemas.microsoft.com/office/drawing/2014/main" id="{DCA585D3-7A65-1858-4000-96151B0FB1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2340" y="828122"/>
            <a:ext cx="4899660" cy="5420163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0208F02-F87D-F600-2623-03D0DDDEAA37}"/>
              </a:ext>
            </a:extLst>
          </p:cNvPr>
          <p:cNvSpPr/>
          <p:nvPr/>
        </p:nvSpPr>
        <p:spPr>
          <a:xfrm>
            <a:off x="7292340" y="4130040"/>
            <a:ext cx="4899660" cy="23622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49529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C39A04-095D-6466-EAE2-49C0715CB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81" y="1414577"/>
            <a:ext cx="11071654" cy="936901"/>
          </a:xfrm>
        </p:spPr>
        <p:txBody>
          <a:bodyPr/>
          <a:lstStyle/>
          <a:p>
            <a:r>
              <a:rPr lang="en-US" dirty="0"/>
              <a:t>Results (III) – Risk stratific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343DDA-D32A-66F6-F258-0722FC491D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632284"/>
            <a:ext cx="4851422" cy="3503045"/>
          </a:xfrm>
        </p:spPr>
        <p:txBody>
          <a:bodyPr>
            <a:normAutofit/>
          </a:bodyPr>
          <a:lstStyle/>
          <a:p>
            <a:r>
              <a:rPr lang="en-US"/>
              <a:t>In the </a:t>
            </a:r>
            <a:r>
              <a:rPr lang="en-US" b="1">
                <a:solidFill>
                  <a:srgbClr val="C00000"/>
                </a:solidFill>
              </a:rPr>
              <a:t>no response</a:t>
            </a:r>
            <a:r>
              <a:rPr lang="en-US" b="1"/>
              <a:t> </a:t>
            </a:r>
            <a:r>
              <a:rPr lang="en-US" dirty="0"/>
              <a:t>group, 18/42 (43%) patients developed LN relapse (‘high risk’). </a:t>
            </a:r>
          </a:p>
          <a:p>
            <a:r>
              <a:rPr lang="en-US" b="1" baseline="30000"/>
              <a:t> </a:t>
            </a:r>
            <a:r>
              <a:rPr lang="en-US" b="1">
                <a:solidFill>
                  <a:srgbClr val="CDA809"/>
                </a:solidFill>
              </a:rPr>
              <a:t>LLDAS-only</a:t>
            </a:r>
            <a:r>
              <a:rPr lang="en-US"/>
              <a:t> and </a:t>
            </a:r>
            <a:r>
              <a:rPr lang="en-US" b="1" dirty="0">
                <a:solidFill>
                  <a:srgbClr val="CDA809"/>
                </a:solidFill>
              </a:rPr>
              <a:t>CRR</a:t>
            </a:r>
            <a:r>
              <a:rPr lang="en-US" b="1">
                <a:solidFill>
                  <a:srgbClr val="CDA809"/>
                </a:solidFill>
              </a:rPr>
              <a:t>/PRR-only</a:t>
            </a:r>
            <a:r>
              <a:rPr lang="en-US"/>
              <a:t> </a:t>
            </a:r>
            <a:r>
              <a:rPr lang="en-US" dirty="0"/>
              <a:t>groups had reduced risk of </a:t>
            </a:r>
            <a:r>
              <a:rPr lang="en-US"/>
              <a:t>LN relapse.</a:t>
            </a:r>
            <a:endParaRPr lang="en-US" dirty="0"/>
          </a:p>
          <a:p>
            <a:r>
              <a:rPr lang="en-US" dirty="0"/>
              <a:t>The lowest relapse risk was observed in the </a:t>
            </a:r>
            <a:r>
              <a:rPr lang="en-US" b="1" dirty="0">
                <a:solidFill>
                  <a:schemeClr val="tx2">
                    <a:lumMod val="75000"/>
                    <a:lumOff val="25000"/>
                  </a:schemeClr>
                </a:solidFill>
              </a:rPr>
              <a:t>CRR/PRR and </a:t>
            </a:r>
            <a:r>
              <a:rPr lang="en-US" b="1">
                <a:solidFill>
                  <a:schemeClr val="tx2">
                    <a:lumMod val="75000"/>
                    <a:lumOff val="25000"/>
                  </a:schemeClr>
                </a:solidFill>
              </a:rPr>
              <a:t>LLDAS</a:t>
            </a:r>
            <a:r>
              <a:rPr lang="en-US"/>
              <a:t> group.</a:t>
            </a:r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CF0EC7-305A-069F-DE6C-87BAE8FEF3F6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369793"/>
            <a:ext cx="11048485" cy="438592"/>
          </a:xfrm>
        </p:spPr>
        <p:txBody>
          <a:bodyPr>
            <a:normAutofit lnSpcReduction="10000"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</a:t>
            </a:r>
            <a:r>
              <a:rPr lang="en-HK" sz="1400" b="0" i="0" u="none" strike="noStrike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long-term kidney function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5A41BEC-293D-0256-F108-894C46DB47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98962" y="2162173"/>
            <a:ext cx="6076495" cy="4128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62941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C7562-479B-A6DC-C0FC-AEBC592ACA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ults (IV) – Relapse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DFE193-2D12-0F2B-5EA1-EB58AD02C5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5481" y="2632284"/>
            <a:ext cx="6641139" cy="3084305"/>
          </a:xfrm>
        </p:spPr>
        <p:txBody>
          <a:bodyPr>
            <a:normAutofit/>
          </a:bodyPr>
          <a:lstStyle/>
          <a:p>
            <a:r>
              <a:rPr lang="en-US" dirty="0"/>
              <a:t>LLDAS attainment at 12 months (HR 0.38, 95% </a:t>
            </a:r>
            <a:r>
              <a:rPr lang="en-US"/>
              <a:t>CI 0.16–0.91, </a:t>
            </a:r>
            <a:r>
              <a:rPr lang="en-US" i="1"/>
              <a:t>P </a:t>
            </a:r>
            <a:r>
              <a:rPr lang="en-US"/>
              <a:t>= 0.029</a:t>
            </a:r>
            <a:r>
              <a:rPr lang="en-US" dirty="0"/>
              <a:t>) reduced LN relapse risk in multivariate analysis of the discovery cohort (Table on the right)</a:t>
            </a:r>
          </a:p>
          <a:p>
            <a:r>
              <a:rPr lang="en-US" dirty="0"/>
              <a:t>The validation cohort confirmed </a:t>
            </a:r>
            <a:r>
              <a:rPr lang="en-US"/>
              <a:t>the finding that </a:t>
            </a:r>
            <a:r>
              <a:rPr lang="en-US" dirty="0"/>
              <a:t>LLDAS attainment reduced LN relapse (LLDAS attainment: HR 0.40, </a:t>
            </a:r>
            <a:r>
              <a:rPr lang="en-US"/>
              <a:t>95% CI 0.19–0.86, </a:t>
            </a:r>
            <a:r>
              <a:rPr lang="en-US" i="1"/>
              <a:t>P </a:t>
            </a:r>
            <a:r>
              <a:rPr lang="en-US"/>
              <a:t>= 0.018</a:t>
            </a:r>
            <a:r>
              <a:rPr lang="en-US" dirty="0"/>
              <a:t>)</a:t>
            </a:r>
          </a:p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E7F5EF-D6AA-7E40-287F-85483D02C2F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1" y="6178550"/>
            <a:ext cx="7001181" cy="568325"/>
          </a:xfrm>
        </p:spPr>
        <p:txBody>
          <a:bodyPr>
            <a:normAutofit fontScale="92500" lnSpcReduction="20000"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pic>
        <p:nvPicPr>
          <p:cNvPr id="10" name="Picture 9" descr="A table of numbers and symbols&#10;&#10;Description automatically generated with medium confidence">
            <a:extLst>
              <a:ext uri="{FF2B5EF4-FFF2-40B4-BE49-F238E27FC236}">
                <a16:creationId xmlns:a16="http://schemas.microsoft.com/office/drawing/2014/main" id="{2FAD2C4A-0482-C70B-232B-23D3E8E3E16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888" b="1000"/>
          <a:stretch>
            <a:fillRect/>
          </a:stretch>
        </p:blipFill>
        <p:spPr>
          <a:xfrm>
            <a:off x="7861555" y="1"/>
            <a:ext cx="4330446" cy="6824672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8AE748C-1A6B-8693-B51B-95E2E8117FF6}"/>
              </a:ext>
            </a:extLst>
          </p:cNvPr>
          <p:cNvSpPr/>
          <p:nvPr/>
        </p:nvSpPr>
        <p:spPr>
          <a:xfrm>
            <a:off x="7900235" y="6366510"/>
            <a:ext cx="4291766" cy="22479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Arc 24">
            <a:extLst>
              <a:ext uri="{FF2B5EF4-FFF2-40B4-BE49-F238E27FC236}">
                <a16:creationId xmlns:a16="http://schemas.microsoft.com/office/drawing/2014/main" id="{7FC9C7F8-8D44-C621-08F9-5A53F6B7BD93}"/>
              </a:ext>
            </a:extLst>
          </p:cNvPr>
          <p:cNvSpPr/>
          <p:nvPr/>
        </p:nvSpPr>
        <p:spPr>
          <a:xfrm>
            <a:off x="3642361" y="3832860"/>
            <a:ext cx="4257874" cy="3604260"/>
          </a:xfrm>
          <a:prstGeom prst="arc">
            <a:avLst>
              <a:gd name="adj1" fmla="val 16256264"/>
              <a:gd name="adj2" fmla="val 21577742"/>
            </a:avLst>
          </a:prstGeom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E8621EBC-80C4-6EF3-F1C5-2A359ACBDA1D}"/>
              </a:ext>
            </a:extLst>
          </p:cNvPr>
          <p:cNvCxnSpPr>
            <a:cxnSpLocks/>
          </p:cNvCxnSpPr>
          <p:nvPr/>
        </p:nvCxnSpPr>
        <p:spPr>
          <a:xfrm>
            <a:off x="7900235" y="5596890"/>
            <a:ext cx="32185" cy="769620"/>
          </a:xfrm>
          <a:prstGeom prst="straightConnector1">
            <a:avLst/>
          </a:prstGeom>
          <a:ln w="28575">
            <a:solidFill>
              <a:srgbClr val="FF0000"/>
            </a:solidFill>
            <a:prstDash val="sysDot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55324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2" grpId="1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70F3C1-4EAA-F0D2-D2E0-9BE405963C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3626" y="2632284"/>
            <a:ext cx="3881913" cy="3084305"/>
          </a:xfrm>
        </p:spPr>
        <p:txBody>
          <a:bodyPr/>
          <a:lstStyle/>
          <a:p>
            <a:r>
              <a:rPr lang="en-US" dirty="0"/>
              <a:t>Attainment of both </a:t>
            </a:r>
            <a:r>
              <a:rPr lang="en-US" b="1" dirty="0">
                <a:solidFill>
                  <a:schemeClr val="tx2">
                    <a:lumMod val="75000"/>
                    <a:lumOff val="25000"/>
                  </a:schemeClr>
                </a:solidFill>
              </a:rPr>
              <a:t>CRR/ PRR and LLDAS</a:t>
            </a:r>
            <a:r>
              <a:rPr lang="en-US" dirty="0"/>
              <a:t> at 12 months was associated with best relapse-free </a:t>
            </a:r>
            <a:r>
              <a:rPr lang="en-US"/>
              <a:t>survival (</a:t>
            </a:r>
            <a:r>
              <a:rPr lang="en-US" i="1"/>
              <a:t>P </a:t>
            </a:r>
            <a:r>
              <a:rPr lang="en-US"/>
              <a:t>&lt; 0.001</a:t>
            </a:r>
            <a:r>
              <a:rPr lang="en-US" dirty="0"/>
              <a:t>). 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188AC0-B3CD-251F-8315-B49837FAEEC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282813"/>
            <a:ext cx="11072813" cy="464062"/>
          </a:xfrm>
        </p:spPr>
        <p:txBody>
          <a:bodyPr>
            <a:normAutofit lnSpcReduction="10000"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pic>
        <p:nvPicPr>
          <p:cNvPr id="8" name="Picture 7" descr="A graph of numbers and a number of events&#10;&#10;Description automatically generated">
            <a:extLst>
              <a:ext uri="{FF2B5EF4-FFF2-40B4-BE49-F238E27FC236}">
                <a16:creationId xmlns:a16="http://schemas.microsoft.com/office/drawing/2014/main" id="{04C9002A-44A6-36B6-AE40-E8996F2552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3279" y="1487152"/>
            <a:ext cx="7088184" cy="474016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834DCFA-1B94-4901-28F6-8D1436F71496}"/>
              </a:ext>
            </a:extLst>
          </p:cNvPr>
          <p:cNvSpPr txBox="1"/>
          <p:nvPr/>
        </p:nvSpPr>
        <p:spPr>
          <a:xfrm>
            <a:off x="4133180" y="1333263"/>
            <a:ext cx="80890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umulative </a:t>
            </a:r>
            <a:r>
              <a:rPr lang="en-US" sz="16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risk of relapse over time stratified by renal response and </a:t>
            </a:r>
            <a:r>
              <a:rPr lang="en-US" sz="160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LLDAS attainment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67685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B0733C3F-D180-A2BE-ACA7-9EC3878B6C24}"/>
              </a:ext>
            </a:extLst>
          </p:cNvPr>
          <p:cNvSpPr/>
          <p:nvPr/>
        </p:nvSpPr>
        <p:spPr>
          <a:xfrm>
            <a:off x="4824301" y="5639806"/>
            <a:ext cx="7367699" cy="560147"/>
          </a:xfrm>
          <a:prstGeom prst="rect">
            <a:avLst/>
          </a:prstGeom>
          <a:solidFill>
            <a:srgbClr val="D6F0F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5249FC6-EDFC-4C95-549E-DEC1BFC95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481" y="1464402"/>
            <a:ext cx="11071654" cy="936901"/>
          </a:xfrm>
        </p:spPr>
        <p:txBody>
          <a:bodyPr/>
          <a:lstStyle/>
          <a:p>
            <a:r>
              <a:rPr lang="en-US" dirty="0"/>
              <a:t>Results (V) – renal pre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638576-5B91-19E1-8CEC-3FCCF12B2F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0940" y="2555501"/>
            <a:ext cx="4188544" cy="3084305"/>
          </a:xfrm>
        </p:spPr>
        <p:txBody>
          <a:bodyPr/>
          <a:lstStyle/>
          <a:p>
            <a:r>
              <a:rPr lang="en-US" dirty="0"/>
              <a:t>The area under the ROC curve (AUC) of LLDAS attainment for predicting renal function deterioration was 0.71 in both the discovery and validation cohorts. 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0C7128-478B-17E9-E1AA-FD59DCD58889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628650" y="6263147"/>
            <a:ext cx="11072813" cy="483727"/>
          </a:xfrm>
        </p:spPr>
        <p:txBody>
          <a:bodyPr>
            <a:normAutofit/>
          </a:bodyPr>
          <a:lstStyle/>
          <a:p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Cheung CK, Yap DY, Lee KL, et al. Treating lupus nephritis patients to lupus low disease activity reduces renal relapse and preserves long-term kidney function. </a:t>
            </a:r>
            <a:r>
              <a:rPr lang="en-HK" sz="1400" b="0" i="1" u="none" strike="noStrike" dirty="0">
                <a:solidFill>
                  <a:srgbClr val="212121"/>
                </a:solidFill>
                <a:effectLst/>
                <a:latin typeface="BlinkMacSystemFont"/>
              </a:rPr>
              <a:t>Arthritis Care Res (Hoboken)</a:t>
            </a:r>
            <a:r>
              <a:rPr lang="en-HK" sz="1400" b="0" i="0" u="none" strike="noStrike" dirty="0">
                <a:solidFill>
                  <a:srgbClr val="212121"/>
                </a:solidFill>
                <a:effectLst/>
                <a:highlight>
                  <a:srgbClr val="FFFFFF"/>
                </a:highlight>
                <a:latin typeface="BlinkMacSystemFont"/>
              </a:rPr>
              <a:t>. Published online July 20, 2025. doi:10.1002/acr.25611</a:t>
            </a:r>
            <a:endParaRPr lang="en-US" sz="1400" dirty="0"/>
          </a:p>
        </p:txBody>
      </p:sp>
      <p:pic>
        <p:nvPicPr>
          <p:cNvPr id="6" name="Picture 5" descr="A graph of a function&#10;&#10;Description automatically generated with medium confidence">
            <a:extLst>
              <a:ext uri="{FF2B5EF4-FFF2-40B4-BE49-F238E27FC236}">
                <a16:creationId xmlns:a16="http://schemas.microsoft.com/office/drawing/2014/main" id="{BE2BFCC7-3E6F-0D84-1426-5511076646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4301" y="2249641"/>
            <a:ext cx="7190717" cy="335323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F649B7F-BC82-4FC5-BE25-AE828F5CAC8D}"/>
              </a:ext>
            </a:extLst>
          </p:cNvPr>
          <p:cNvSpPr txBox="1"/>
          <p:nvPr/>
        </p:nvSpPr>
        <p:spPr>
          <a:xfrm>
            <a:off x="5348748" y="5639806"/>
            <a:ext cx="66662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Receiver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operating characteristic curve of LLDAS attainment for renal function deterioration in </a:t>
            </a:r>
            <a:r>
              <a:rPr lang="en-US" sz="140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the discovery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ohort (Left) </a:t>
            </a:r>
            <a:r>
              <a:rPr lang="en-US" sz="140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and validation </a:t>
            </a:r>
            <a:r>
              <a:rPr lang="en-US" sz="1400" dirty="0">
                <a:effectLst/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cohort (Right).</a:t>
            </a:r>
            <a:r>
              <a:rPr lang="en-HK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AC582FD-3549-541A-C2C4-99FD82A367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2140" b="94293" l="3621" r="97780">
                        <a14:foregroundMark x1="51519" y1="13436" x2="35864" y2="28062"/>
                        <a14:foregroundMark x1="35864" y1="28062" x2="28972" y2="69322"/>
                        <a14:foregroundMark x1="28972" y1="69322" x2="71495" y2="59453"/>
                        <a14:foregroundMark x1="71495" y1="59453" x2="76986" y2="37218"/>
                        <a14:foregroundMark x1="76869" y1="37218" x2="52336" y2="12010"/>
                        <a14:foregroundMark x1="52336" y1="12010" x2="51168" y2="11177"/>
                        <a14:foregroundMark x1="51519" y1="3448" x2="51976" y2="3262"/>
                        <a14:foregroundMark x1="56192" y1="3924" x2="59696" y2="5470"/>
                        <a14:foregroundMark x1="60631" y1="5232" x2="63785" y2="6897"/>
                        <a14:foregroundMark x1="66121" y1="6897" x2="69393" y2="9037"/>
                        <a14:foregroundMark x1="71028" y1="9631" x2="65537" y2="6064"/>
                        <a14:foregroundMark x1="66668" y1="7288" x2="95091" y2="60541"/>
                        <a14:foregroundMark x1="17991" y1="33175" x2="6969" y2="35933"/>
                        <a14:foregroundMark x1="16589" y1="49227" x2="33879" y2="86088"/>
                        <a14:foregroundMark x1="33879" y1="86088" x2="44860" y2="94293"/>
                        <a14:foregroundMark x1="60514" y1="91082" x2="69042" y2="88704"/>
                        <a14:backgroundMark x1="5140" y1="36147" x2="5140" y2="36147"/>
                        <a14:backgroundMark x1="5491" y1="35196" x2="4556" y2="36980"/>
                        <a14:backgroundMark x1="96846" y1="61831" x2="96846" y2="63734"/>
                        <a14:backgroundMark x1="97313" y1="61237" x2="97313" y2="61237"/>
                        <a14:backgroundMark x1="96145" y1="60761" x2="95561" y2="63615"/>
                        <a14:backgroundMark x1="98248" y1="64923" x2="97897" y2="67182"/>
                        <a14:backgroundMark x1="97664" y1="63615" x2="97079" y2="65161"/>
                        <a14:backgroundMark x1="54673" y1="2259" x2="52336" y2="2497"/>
                        <a14:backgroundMark x1="53154" y1="3092" x2="51869" y2="3092"/>
                        <a14:backgroundMark x1="67290" y1="5589" x2="64836" y2="4875"/>
                        <a14:backgroundMark x1="88551" y1="79191" x2="87617" y2="79667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95137" y="5352642"/>
            <a:ext cx="953611" cy="936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7417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</TotalTime>
  <Words>1176</Words>
  <Application>Microsoft Office PowerPoint</Application>
  <PresentationFormat>Widescreen</PresentationFormat>
  <Paragraphs>5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BlinkMacSystemFont</vt:lpstr>
      <vt:lpstr>Office Theme</vt:lpstr>
      <vt:lpstr>Treating Lupus Nephritis Patients to Lupus Low Disease Activity Reduces Renal Relapse and Preserves Long-Term Kidney Function</vt:lpstr>
      <vt:lpstr>Background</vt:lpstr>
      <vt:lpstr>Methods</vt:lpstr>
      <vt:lpstr>Results (I) – Attainability</vt:lpstr>
      <vt:lpstr>Results (II) – Predictors</vt:lpstr>
      <vt:lpstr>Results (III) – Risk stratification</vt:lpstr>
      <vt:lpstr>Results (IV) – Relapse </vt:lpstr>
      <vt:lpstr>PowerPoint Presentation</vt:lpstr>
      <vt:lpstr>Results (V) – renal preservation</vt:lpstr>
      <vt:lpstr>Discuss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rb Aden</dc:creator>
  <cp:lastModifiedBy>Brian Robinson</cp:lastModifiedBy>
  <cp:revision>6</cp:revision>
  <dcterms:created xsi:type="dcterms:W3CDTF">2025-01-16T19:43:53Z</dcterms:created>
  <dcterms:modified xsi:type="dcterms:W3CDTF">2025-10-21T17:48:25Z</dcterms:modified>
</cp:coreProperties>
</file>